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150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M:\College%20Work\Data\Vitamin%20D%20-%20Layers%20and%20Immunity%20June%202018\Ash\Warren_MF_Ca_P_figures_3_5_20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M:\College%20Work\Data\Vitamin%20D%20-%20Layers%20and%20Immunity%20June%202018\Ash\Warren_MF_Ca_P_figures_3_5_20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M:\College%20Work\Data\Vitamin%20D%20-%20Layers%20and%20Immunity%20June%202018\qPCR\Warren_MF_Kidney_qPCR_figure_3_4_202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M:\College%20Work\Data\Vitamin%20D%20-%20Layers%20and%20Immunity%20June%202018\qPCR\Warren_MF_Kidney_qPCR_figure_3_4_2020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744996719160105"/>
          <c:y val="7.6388888888888895E-2"/>
          <c:w val="0.78162401574803153"/>
          <c:h val="0.61764982502187227"/>
        </c:manualLayout>
      </c:layout>
      <c:lineChart>
        <c:grouping val="standard"/>
        <c:varyColors val="0"/>
        <c:ser>
          <c:idx val="0"/>
          <c:order val="0"/>
          <c:tx>
            <c:v>Tibia</c:v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1"/>
              </a:solidFill>
              <a:ln w="1587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square"/>
              <c:size val="5"/>
              <c:spPr>
                <a:solidFill>
                  <a:schemeClr val="accent1"/>
                </a:solidFill>
                <a:ln w="1587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0F61-4440-A631-C2A3EAAEF9C0}"/>
              </c:ext>
            </c:extLst>
          </c:dPt>
          <c:dPt>
            <c:idx val="3"/>
            <c:marker>
              <c:symbol val="square"/>
              <c:size val="5"/>
              <c:spPr>
                <a:solidFill>
                  <a:schemeClr val="accent1"/>
                </a:solidFill>
                <a:ln w="1587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0F61-4440-A631-C2A3EAAEF9C0}"/>
              </c:ext>
            </c:extLst>
          </c:dPt>
          <c:dPt>
            <c:idx val="4"/>
            <c:marker>
              <c:symbol val="square"/>
              <c:size val="5"/>
              <c:spPr>
                <a:solidFill>
                  <a:schemeClr val="accent1"/>
                </a:solidFill>
                <a:ln w="1587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0F61-4440-A631-C2A3EAAEF9C0}"/>
              </c:ext>
            </c:extLst>
          </c:dPt>
          <c:dPt>
            <c:idx val="5"/>
            <c:marker>
              <c:symbol val="square"/>
              <c:size val="5"/>
              <c:spPr>
                <a:solidFill>
                  <a:schemeClr val="accent1"/>
                </a:solidFill>
                <a:ln w="1587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0F61-4440-A631-C2A3EAAEF9C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Bone!$Y$18:$Y$23</c:f>
                <c:numCache>
                  <c:formatCode>General</c:formatCode>
                  <c:ptCount val="6"/>
                  <c:pt idx="0">
                    <c:v>1.07</c:v>
                  </c:pt>
                  <c:pt idx="1">
                    <c:v>1</c:v>
                  </c:pt>
                  <c:pt idx="2">
                    <c:v>0.57099999999999995</c:v>
                  </c:pt>
                  <c:pt idx="3">
                    <c:v>1.8</c:v>
                  </c:pt>
                  <c:pt idx="4">
                    <c:v>1.8</c:v>
                  </c:pt>
                  <c:pt idx="5">
                    <c:v>1.53</c:v>
                  </c:pt>
                </c:numCache>
              </c:numRef>
            </c:plus>
            <c:minus>
              <c:numRef>
                <c:f>Bone!$Y$18:$Y$23</c:f>
                <c:numCache>
                  <c:formatCode>General</c:formatCode>
                  <c:ptCount val="6"/>
                  <c:pt idx="0">
                    <c:v>1.07</c:v>
                  </c:pt>
                  <c:pt idx="1">
                    <c:v>1</c:v>
                  </c:pt>
                  <c:pt idx="2">
                    <c:v>0.57099999999999995</c:v>
                  </c:pt>
                  <c:pt idx="3">
                    <c:v>1.8</c:v>
                  </c:pt>
                  <c:pt idx="4">
                    <c:v>1.8</c:v>
                  </c:pt>
                  <c:pt idx="5">
                    <c:v>1.53</c:v>
                  </c:pt>
                </c:numCache>
              </c:numRef>
            </c:minus>
            <c:spPr>
              <a:noFill/>
              <a:ln w="15875" cap="sq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one!$X$2:$X$7</c:f>
              <c:numCache>
                <c:formatCode>General</c:formatCode>
                <c:ptCount val="6"/>
                <c:pt idx="0">
                  <c:v>400</c:v>
                </c:pt>
                <c:pt idx="1">
                  <c:v>800</c:v>
                </c:pt>
                <c:pt idx="2" formatCode="#,##0">
                  <c:v>7400</c:v>
                </c:pt>
                <c:pt idx="3" formatCode="#,##0">
                  <c:v>14000</c:v>
                </c:pt>
                <c:pt idx="4" formatCode="#,##0">
                  <c:v>20000</c:v>
                </c:pt>
                <c:pt idx="5" formatCode="#,##0">
                  <c:v>36000</c:v>
                </c:pt>
              </c:numCache>
            </c:numRef>
          </c:cat>
          <c:val>
            <c:numRef>
              <c:f>Bone!$Y$2:$Y$7</c:f>
              <c:numCache>
                <c:formatCode>General</c:formatCode>
                <c:ptCount val="6"/>
                <c:pt idx="0">
                  <c:v>14.532913750000001</c:v>
                </c:pt>
                <c:pt idx="1">
                  <c:v>14.670435714285714</c:v>
                </c:pt>
                <c:pt idx="2">
                  <c:v>16.072847142857142</c:v>
                </c:pt>
                <c:pt idx="3">
                  <c:v>13.577554285714285</c:v>
                </c:pt>
                <c:pt idx="4">
                  <c:v>15.682241428571428</c:v>
                </c:pt>
                <c:pt idx="5">
                  <c:v>16.6154057142857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F61-4440-A631-C2A3EAAEF9C0}"/>
            </c:ext>
          </c:extLst>
        </c:ser>
        <c:ser>
          <c:idx val="1"/>
          <c:order val="1"/>
          <c:tx>
            <c:v>Humerus</c:v>
          </c:tx>
          <c:spPr>
            <a:ln w="158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triangle"/>
            <c:size val="5"/>
            <c:spPr>
              <a:solidFill>
                <a:schemeClr val="accent2"/>
              </a:solidFill>
              <a:ln w="1587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triangle"/>
              <c:size val="5"/>
              <c:spPr>
                <a:solidFill>
                  <a:schemeClr val="accent2"/>
                </a:solidFill>
                <a:ln w="1587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0F61-4440-A631-C2A3EAAEF9C0}"/>
              </c:ext>
            </c:extLst>
          </c:dPt>
          <c:dPt>
            <c:idx val="1"/>
            <c:marker>
              <c:symbol val="triangle"/>
              <c:size val="5"/>
              <c:spPr>
                <a:solidFill>
                  <a:schemeClr val="accent2"/>
                </a:solidFill>
                <a:ln w="1587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0F61-4440-A631-C2A3EAAEF9C0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Bone!$Y$24:$Y$29</c:f>
                <c:numCache>
                  <c:formatCode>General</c:formatCode>
                  <c:ptCount val="6"/>
                  <c:pt idx="0">
                    <c:v>1.53</c:v>
                  </c:pt>
                  <c:pt idx="1">
                    <c:v>1.45</c:v>
                  </c:pt>
                  <c:pt idx="2">
                    <c:v>3.21</c:v>
                  </c:pt>
                  <c:pt idx="3">
                    <c:v>1.94</c:v>
                  </c:pt>
                  <c:pt idx="4">
                    <c:v>1.32</c:v>
                  </c:pt>
                  <c:pt idx="5">
                    <c:v>0.86899999999999999</c:v>
                  </c:pt>
                </c:numCache>
              </c:numRef>
            </c:plus>
            <c:minus>
              <c:numRef>
                <c:f>Bone!$Y$24:$Y$29</c:f>
                <c:numCache>
                  <c:formatCode>General</c:formatCode>
                  <c:ptCount val="6"/>
                  <c:pt idx="0">
                    <c:v>1.53</c:v>
                  </c:pt>
                  <c:pt idx="1">
                    <c:v>1.45</c:v>
                  </c:pt>
                  <c:pt idx="2">
                    <c:v>3.21</c:v>
                  </c:pt>
                  <c:pt idx="3">
                    <c:v>1.94</c:v>
                  </c:pt>
                  <c:pt idx="4">
                    <c:v>1.32</c:v>
                  </c:pt>
                  <c:pt idx="5">
                    <c:v>0.86899999999999999</c:v>
                  </c:pt>
                </c:numCache>
              </c:numRef>
            </c:minus>
            <c:spPr>
              <a:noFill/>
              <a:ln w="15875" cap="sq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one!$X$2:$X$7</c:f>
              <c:numCache>
                <c:formatCode>General</c:formatCode>
                <c:ptCount val="6"/>
                <c:pt idx="0">
                  <c:v>400</c:v>
                </c:pt>
                <c:pt idx="1">
                  <c:v>800</c:v>
                </c:pt>
                <c:pt idx="2" formatCode="#,##0">
                  <c:v>7400</c:v>
                </c:pt>
                <c:pt idx="3" formatCode="#,##0">
                  <c:v>14000</c:v>
                </c:pt>
                <c:pt idx="4" formatCode="#,##0">
                  <c:v>20000</c:v>
                </c:pt>
                <c:pt idx="5" formatCode="#,##0">
                  <c:v>36000</c:v>
                </c:pt>
              </c:numCache>
            </c:numRef>
          </c:cat>
          <c:val>
            <c:numRef>
              <c:f>Bone!$Y$8:$Y$13</c:f>
              <c:numCache>
                <c:formatCode>General</c:formatCode>
                <c:ptCount val="6"/>
                <c:pt idx="0">
                  <c:v>17.466603750000001</c:v>
                </c:pt>
                <c:pt idx="1">
                  <c:v>16.649236999999999</c:v>
                </c:pt>
                <c:pt idx="2">
                  <c:v>19.064145</c:v>
                </c:pt>
                <c:pt idx="3">
                  <c:v>18.511632857142853</c:v>
                </c:pt>
                <c:pt idx="4">
                  <c:v>15.081248333333335</c:v>
                </c:pt>
                <c:pt idx="5">
                  <c:v>16.8858685714285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0F61-4440-A631-C2A3EAAEF9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2014384"/>
        <c:axId val="524768032"/>
      </c:lineChart>
      <c:catAx>
        <c:axId val="222014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Dietary Vitamin D</a:t>
                </a:r>
                <a:r>
                  <a:rPr lang="en-US" baseline="-25000" dirty="0"/>
                  <a:t>3</a:t>
                </a:r>
                <a:r>
                  <a:rPr lang="en-US" dirty="0"/>
                  <a:t> Levels (IU/k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15875" cap="sq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4768032"/>
        <c:crosses val="autoZero"/>
        <c:auto val="1"/>
        <c:lblAlgn val="ctr"/>
        <c:lblOffset val="100"/>
        <c:noMultiLvlLbl val="0"/>
      </c:catAx>
      <c:valAx>
        <c:axId val="524768032"/>
        <c:scaling>
          <c:orientation val="minMax"/>
          <c:max val="2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Bone Calcium (% of weight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15875" cap="sq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2014384"/>
        <c:crosses val="autoZero"/>
        <c:crossBetween val="between"/>
        <c:majorUnit val="6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57452974628172"/>
          <c:y val="5.3905949256342942E-2"/>
          <c:w val="0.30227836103820355"/>
          <c:h val="0.159346456692913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v>Tibia</c:v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accent1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ne!$Z$18:$Z$23</c:f>
                <c:numCache>
                  <c:formatCode>General</c:formatCode>
                  <c:ptCount val="6"/>
                  <c:pt idx="0">
                    <c:v>0.51600000000000001</c:v>
                  </c:pt>
                  <c:pt idx="1">
                    <c:v>0.432</c:v>
                  </c:pt>
                  <c:pt idx="2">
                    <c:v>0.24099999999999999</c:v>
                  </c:pt>
                  <c:pt idx="3">
                    <c:v>0.83</c:v>
                  </c:pt>
                  <c:pt idx="4">
                    <c:v>0.873</c:v>
                  </c:pt>
                  <c:pt idx="5">
                    <c:v>0.68500000000000005</c:v>
                  </c:pt>
                </c:numCache>
              </c:numRef>
            </c:plus>
            <c:minus>
              <c:numRef>
                <c:f>Bone!$Z$18:$Z$23</c:f>
                <c:numCache>
                  <c:formatCode>General</c:formatCode>
                  <c:ptCount val="6"/>
                  <c:pt idx="0">
                    <c:v>0.51600000000000001</c:v>
                  </c:pt>
                  <c:pt idx="1">
                    <c:v>0.432</c:v>
                  </c:pt>
                  <c:pt idx="2">
                    <c:v>0.24099999999999999</c:v>
                  </c:pt>
                  <c:pt idx="3">
                    <c:v>0.83</c:v>
                  </c:pt>
                  <c:pt idx="4">
                    <c:v>0.873</c:v>
                  </c:pt>
                  <c:pt idx="5">
                    <c:v>0.68500000000000005</c:v>
                  </c:pt>
                </c:numCache>
              </c:numRef>
            </c:minus>
            <c:spPr>
              <a:noFill/>
              <a:ln w="15875" cap="sq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one!$X$2:$X$7</c:f>
              <c:numCache>
                <c:formatCode>General</c:formatCode>
                <c:ptCount val="6"/>
                <c:pt idx="0">
                  <c:v>400</c:v>
                </c:pt>
                <c:pt idx="1">
                  <c:v>800</c:v>
                </c:pt>
                <c:pt idx="2" formatCode="#,##0">
                  <c:v>7400</c:v>
                </c:pt>
                <c:pt idx="3" formatCode="#,##0">
                  <c:v>14000</c:v>
                </c:pt>
                <c:pt idx="4" formatCode="#,##0">
                  <c:v>20000</c:v>
                </c:pt>
                <c:pt idx="5" formatCode="#,##0">
                  <c:v>36000</c:v>
                </c:pt>
              </c:numCache>
            </c:numRef>
          </c:cat>
          <c:val>
            <c:numRef>
              <c:f>Bone!$Z$2:$Z$7</c:f>
              <c:numCache>
                <c:formatCode>###0.00;\-###0.00</c:formatCode>
                <c:ptCount val="6"/>
                <c:pt idx="0">
                  <c:v>6.9040237499999986</c:v>
                </c:pt>
                <c:pt idx="1">
                  <c:v>6.9906138571428569</c:v>
                </c:pt>
                <c:pt idx="2">
                  <c:v>7.7091152857142848</c:v>
                </c:pt>
                <c:pt idx="3">
                  <c:v>7.1323857142857134</c:v>
                </c:pt>
                <c:pt idx="4">
                  <c:v>7.549435714285714</c:v>
                </c:pt>
                <c:pt idx="5">
                  <c:v>7.7614442857142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A88-4DBF-A70C-18AB3C383E21}"/>
            </c:ext>
          </c:extLst>
        </c:ser>
        <c:ser>
          <c:idx val="1"/>
          <c:order val="1"/>
          <c:tx>
            <c:v>Humerus</c:v>
          </c:tx>
          <c:spPr>
            <a:ln w="1587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triangle"/>
            <c:size val="5"/>
            <c:spPr>
              <a:solidFill>
                <a:schemeClr val="accent2"/>
              </a:solidFill>
              <a:ln w="158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ne!$Z$24:$Z$29</c:f>
                <c:numCache>
                  <c:formatCode>General</c:formatCode>
                  <c:ptCount val="6"/>
                  <c:pt idx="0">
                    <c:v>0.79200000000000004</c:v>
                  </c:pt>
                  <c:pt idx="1">
                    <c:v>0.73</c:v>
                  </c:pt>
                  <c:pt idx="2">
                    <c:v>1.56</c:v>
                  </c:pt>
                  <c:pt idx="3">
                    <c:v>0.90700000000000003</c:v>
                  </c:pt>
                  <c:pt idx="4">
                    <c:v>0.65800000000000003</c:v>
                  </c:pt>
                  <c:pt idx="5">
                    <c:v>0.44900000000000001</c:v>
                  </c:pt>
                </c:numCache>
              </c:numRef>
            </c:plus>
            <c:minus>
              <c:numRef>
                <c:f>Bone!$Z$24:$Z$29</c:f>
                <c:numCache>
                  <c:formatCode>General</c:formatCode>
                  <c:ptCount val="6"/>
                  <c:pt idx="0">
                    <c:v>0.79200000000000004</c:v>
                  </c:pt>
                  <c:pt idx="1">
                    <c:v>0.73</c:v>
                  </c:pt>
                  <c:pt idx="2">
                    <c:v>1.56</c:v>
                  </c:pt>
                  <c:pt idx="3">
                    <c:v>0.90700000000000003</c:v>
                  </c:pt>
                  <c:pt idx="4">
                    <c:v>0.65800000000000003</c:v>
                  </c:pt>
                  <c:pt idx="5">
                    <c:v>0.44900000000000001</c:v>
                  </c:pt>
                </c:numCache>
              </c:numRef>
            </c:minus>
            <c:spPr>
              <a:noFill/>
              <a:ln w="15875" cap="sq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one!$X$2:$X$7</c:f>
              <c:numCache>
                <c:formatCode>General</c:formatCode>
                <c:ptCount val="6"/>
                <c:pt idx="0">
                  <c:v>400</c:v>
                </c:pt>
                <c:pt idx="1">
                  <c:v>800</c:v>
                </c:pt>
                <c:pt idx="2" formatCode="#,##0">
                  <c:v>7400</c:v>
                </c:pt>
                <c:pt idx="3" formatCode="#,##0">
                  <c:v>14000</c:v>
                </c:pt>
                <c:pt idx="4" formatCode="#,##0">
                  <c:v>20000</c:v>
                </c:pt>
                <c:pt idx="5" formatCode="#,##0">
                  <c:v>36000</c:v>
                </c:pt>
              </c:numCache>
            </c:numRef>
          </c:cat>
          <c:val>
            <c:numRef>
              <c:f>Bone!$Z$8:$Z$13</c:f>
              <c:numCache>
                <c:formatCode>General</c:formatCode>
                <c:ptCount val="6"/>
                <c:pt idx="0">
                  <c:v>8.4862925000000011</c:v>
                </c:pt>
                <c:pt idx="1">
                  <c:v>8.1129442857142866</c:v>
                </c:pt>
                <c:pt idx="2">
                  <c:v>9.2123849999999994</c:v>
                </c:pt>
                <c:pt idx="3">
                  <c:v>9.0107885714285718</c:v>
                </c:pt>
                <c:pt idx="4">
                  <c:v>7.3019466666666686</c:v>
                </c:pt>
                <c:pt idx="5">
                  <c:v>8.16431714285714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A88-4DBF-A70C-18AB3C383E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2014384"/>
        <c:axId val="524768032"/>
      </c:lineChart>
      <c:catAx>
        <c:axId val="222014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Dietary Vitamin D</a:t>
                </a:r>
                <a:r>
                  <a:rPr lang="en-US" baseline="-25000" dirty="0"/>
                  <a:t>3</a:t>
                </a:r>
                <a:r>
                  <a:rPr lang="en-US" dirty="0"/>
                  <a:t> Levels (IU/k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15875" cap="sq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4768032"/>
        <c:crosses val="autoZero"/>
        <c:auto val="1"/>
        <c:lblAlgn val="ctr"/>
        <c:lblOffset val="100"/>
        <c:noMultiLvlLbl val="0"/>
      </c:catAx>
      <c:valAx>
        <c:axId val="524768032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Bone Phosphorus (% of weight)</a:t>
                </a:r>
              </a:p>
            </c:rich>
          </c:tx>
          <c:layout>
            <c:manualLayout>
              <c:xMode val="edge"/>
              <c:yMode val="edge"/>
              <c:x val="4.5138888888888888E-2"/>
              <c:y val="7.983770778652668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15875" cap="sq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2014384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297490157480313"/>
          <c:y val="5.9020122484689429E-2"/>
          <c:w val="0.26848452537182849"/>
          <c:h val="0.18124015748031494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451251358731675"/>
          <c:y val="7.6388888888888895E-2"/>
          <c:w val="0.729191190116387"/>
          <c:h val="0.672338145231845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4-OHase Figure'!$T$4:$T$5</c:f>
              <c:strCache>
                <c:ptCount val="2"/>
                <c:pt idx="0">
                  <c:v>Relative Expression</c:v>
                </c:pt>
                <c:pt idx="1">
                  <c:v>Mean</c:v>
                </c:pt>
              </c:strCache>
            </c:strRef>
          </c:tx>
          <c:spPr>
            <a:solidFill>
              <a:srgbClr val="FF0000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72B3-40EF-9637-97D03ADD482F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2B3-40EF-9637-97D03ADD482F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2B3-40EF-9637-97D03ADD482F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2B3-40EF-9637-97D03ADD482F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2B3-40EF-9637-97D03ADD482F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2B3-40EF-9637-97D03ADD482F}"/>
              </c:ext>
            </c:extLst>
          </c:dPt>
          <c:dLbls>
            <c:dLbl>
              <c:idx val="0"/>
              <c:layout>
                <c:manualLayout>
                  <c:x val="0"/>
                  <c:y val="-2.3148148148148147E-2"/>
                </c:manualLayout>
              </c:layout>
              <c:tx>
                <c:strRef>
                  <c:f>'24-OHase Figure'!$U$6</c:f>
                  <c:strCache>
                    <c:ptCount val="1"/>
                    <c:pt idx="0">
                      <c:v>a</c:v>
                    </c:pt>
                  </c:strCache>
                </c:strRef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>
                    <c15:dlblFTEntry>
                      <c15:txfldGUID>{A8400798-7262-4E68-BE02-26FE6B34E467}</c15:txfldGUID>
                      <c15:f>'24-OHase Figure'!$U$6</c15:f>
                      <c15:dlblFieldTableCache>
                        <c:ptCount val="1"/>
                        <c:pt idx="0">
                          <c:v>a</c:v>
                        </c:pt>
                      </c15:dlblFieldTableCache>
                    </c15:dlblFTEntry>
                  </c15:dlblFieldTable>
                  <c15:showDataLabelsRange val="0"/>
                </c:ext>
                <c:ext xmlns:c16="http://schemas.microsoft.com/office/drawing/2014/chart" uri="{C3380CC4-5D6E-409C-BE32-E72D297353CC}">
                  <c16:uniqueId val="{00000008-72B3-40EF-9637-97D03ADD482F}"/>
                </c:ext>
              </c:extLst>
            </c:dLbl>
            <c:dLbl>
              <c:idx val="1"/>
              <c:layout>
                <c:manualLayout>
                  <c:x val="0"/>
                  <c:y val="-5.555555555555558E-2"/>
                </c:manualLayout>
              </c:layout>
              <c:tx>
                <c:strRef>
                  <c:f>'24-OHase Figure'!$U$7</c:f>
                  <c:strCache>
                    <c:ptCount val="1"/>
                    <c:pt idx="0">
                      <c:v>a</c:v>
                    </c:pt>
                  </c:strCache>
                </c:strRef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>
                    <c15:dlblFTEntry>
                      <c15:txfldGUID>{3B3C046C-8202-4DE4-8493-43BF96683598}</c15:txfldGUID>
                      <c15:f>'24-OHase Figure'!$U$7</c15:f>
                      <c15:dlblFieldTableCache>
                        <c:ptCount val="1"/>
                        <c:pt idx="0">
                          <c:v>a</c:v>
                        </c:pt>
                      </c15:dlblFieldTableCache>
                    </c15:dlblFTEntry>
                  </c15:dlblFieldTable>
                  <c15:showDataLabelsRange val="0"/>
                </c:ext>
                <c:ext xmlns:c16="http://schemas.microsoft.com/office/drawing/2014/chart" uri="{C3380CC4-5D6E-409C-BE32-E72D297353CC}">
                  <c16:uniqueId val="{00000009-72B3-40EF-9637-97D03ADD482F}"/>
                </c:ext>
              </c:extLst>
            </c:dLbl>
            <c:dLbl>
              <c:idx val="2"/>
              <c:layout>
                <c:manualLayout>
                  <c:x val="0"/>
                  <c:y val="1.1574256342957067E-2"/>
                </c:manualLayout>
              </c:layout>
              <c:tx>
                <c:strRef>
                  <c:f>'24-OHase Figure'!$U$8</c:f>
                  <c:strCache>
                    <c:ptCount val="1"/>
                    <c:pt idx="0">
                      <c:v>b</c:v>
                    </c:pt>
                  </c:strCache>
                </c:strRef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>
                    <c15:dlblFTEntry>
                      <c15:txfldGUID>{8F415CAD-9E37-4C19-9407-8EC0CC9DA600}</c15:txfldGUID>
                      <c15:f>'24-OHase Figure'!$U$8</c15:f>
                      <c15:dlblFieldTableCache>
                        <c:ptCount val="1"/>
                        <c:pt idx="0">
                          <c:v>b</c:v>
                        </c:pt>
                      </c15:dlblFieldTableCache>
                    </c15:dlblFTEntry>
                  </c15:dlblFieldTable>
                  <c15:showDataLabelsRange val="0"/>
                </c:ext>
                <c:ext xmlns:c16="http://schemas.microsoft.com/office/drawing/2014/chart" uri="{C3380CC4-5D6E-409C-BE32-E72D297353CC}">
                  <c16:uniqueId val="{00000001-72B3-40EF-9637-97D03ADD482F}"/>
                </c:ext>
              </c:extLst>
            </c:dLbl>
            <c:dLbl>
              <c:idx val="3"/>
              <c:layout>
                <c:manualLayout>
                  <c:x val="0"/>
                  <c:y val="-1.8518518518518517E-2"/>
                </c:manualLayout>
              </c:layout>
              <c:tx>
                <c:strRef>
                  <c:f>'24-OHase Figure'!$U$9</c:f>
                  <c:strCache>
                    <c:ptCount val="1"/>
                    <c:pt idx="0">
                      <c:v>b</c:v>
                    </c:pt>
                  </c:strCache>
                </c:strRef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>
                    <c15:dlblFTEntry>
                      <c15:txfldGUID>{E3604EDE-C0FB-4BBD-9347-F1A5460975E2}</c15:txfldGUID>
                      <c15:f>'24-OHase Figure'!$U$9</c15:f>
                      <c15:dlblFieldTableCache>
                        <c:ptCount val="1"/>
                        <c:pt idx="0">
                          <c:v>b</c:v>
                        </c:pt>
                      </c15:dlblFieldTableCache>
                    </c15:dlblFTEntry>
                  </c15:dlblFieldTable>
                  <c15:showDataLabelsRange val="0"/>
                </c:ext>
                <c:ext xmlns:c16="http://schemas.microsoft.com/office/drawing/2014/chart" uri="{C3380CC4-5D6E-409C-BE32-E72D297353CC}">
                  <c16:uniqueId val="{00000003-72B3-40EF-9637-97D03ADD482F}"/>
                </c:ext>
              </c:extLst>
            </c:dLbl>
            <c:dLbl>
              <c:idx val="4"/>
              <c:layout>
                <c:manualLayout>
                  <c:x val="0"/>
                  <c:y val="-1.8518518518518517E-2"/>
                </c:manualLayout>
              </c:layout>
              <c:tx>
                <c:strRef>
                  <c:f>'24-OHase Figure'!$U$10</c:f>
                  <c:strCache>
                    <c:ptCount val="1"/>
                    <c:pt idx="0">
                      <c:v>ab</c:v>
                    </c:pt>
                  </c:strCache>
                </c:strRef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>
                    <c15:dlblFTEntry>
                      <c15:txfldGUID>{58F286E2-A769-49AF-B76B-D1DD4B0BD423}</c15:txfldGUID>
                      <c15:f>'24-OHase Figure'!$U$10</c15:f>
                      <c15:dlblFieldTableCache>
                        <c:ptCount val="1"/>
                        <c:pt idx="0">
                          <c:v>ab</c:v>
                        </c:pt>
                      </c15:dlblFieldTableCache>
                    </c15:dlblFTEntry>
                  </c15:dlblFieldTable>
                  <c15:showDataLabelsRange val="0"/>
                </c:ext>
                <c:ext xmlns:c16="http://schemas.microsoft.com/office/drawing/2014/chart" uri="{C3380CC4-5D6E-409C-BE32-E72D297353CC}">
                  <c16:uniqueId val="{00000005-72B3-40EF-9637-97D03ADD482F}"/>
                </c:ext>
              </c:extLst>
            </c:dLbl>
            <c:dLbl>
              <c:idx val="5"/>
              <c:layout>
                <c:manualLayout>
                  <c:x val="0"/>
                  <c:y val="-9.2592592592593437E-3"/>
                </c:manualLayout>
              </c:layout>
              <c:tx>
                <c:strRef>
                  <c:f>'24-OHase Figure'!$U$11</c:f>
                  <c:strCache>
                    <c:ptCount val="1"/>
                    <c:pt idx="0">
                      <c:v>b</c:v>
                    </c:pt>
                  </c:strCache>
                </c:strRef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>
                    <c15:dlblFTEntry>
                      <c15:txfldGUID>{4B45C599-E5B9-4E83-BA01-D2FB8624D835}</c15:txfldGUID>
                      <c15:f>'24-OHase Figure'!$U$11</c15:f>
                      <c15:dlblFieldTableCache>
                        <c:ptCount val="1"/>
                        <c:pt idx="0">
                          <c:v>b</c:v>
                        </c:pt>
                      </c15:dlblFieldTableCache>
                    </c15:dlblFTEntry>
                  </c15:dlblFieldTable>
                  <c15:showDataLabelsRange val="0"/>
                </c:ext>
                <c:ext xmlns:c16="http://schemas.microsoft.com/office/drawing/2014/chart" uri="{C3380CC4-5D6E-409C-BE32-E72D297353CC}">
                  <c16:uniqueId val="{00000007-72B3-40EF-9637-97D03ADD482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clip" horzOverflow="clip" vert="horz" wrap="square" lIns="36576" tIns="18288" rIns="36576" bIns="18288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  <a:noFill/>
                  <a:ln>
                    <a:noFill/>
                  </a:ln>
                </c15:spPr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24-OHase Figure'!$V$6:$V$11</c:f>
                <c:numCache>
                  <c:formatCode>General</c:formatCode>
                  <c:ptCount val="6"/>
                  <c:pt idx="0">
                    <c:v>5.6000000000000001E-2</c:v>
                  </c:pt>
                  <c:pt idx="1">
                    <c:v>0.1</c:v>
                  </c:pt>
                  <c:pt idx="2">
                    <c:v>1.0999999999999999E-2</c:v>
                  </c:pt>
                  <c:pt idx="3">
                    <c:v>4.3999999999999997E-2</c:v>
                  </c:pt>
                  <c:pt idx="4">
                    <c:v>3.5999999999999997E-2</c:v>
                  </c:pt>
                  <c:pt idx="5">
                    <c:v>3.1E-2</c:v>
                  </c:pt>
                </c:numCache>
              </c:numRef>
            </c:plus>
            <c:minus>
              <c:numRef>
                <c:f>'24-OHase Figure'!$V$6:$V$11</c:f>
                <c:numCache>
                  <c:formatCode>General</c:formatCode>
                  <c:ptCount val="6"/>
                  <c:pt idx="0">
                    <c:v>5.6000000000000001E-2</c:v>
                  </c:pt>
                  <c:pt idx="1">
                    <c:v>0.1</c:v>
                  </c:pt>
                  <c:pt idx="2">
                    <c:v>1.0999999999999999E-2</c:v>
                  </c:pt>
                  <c:pt idx="3">
                    <c:v>4.3999999999999997E-2</c:v>
                  </c:pt>
                  <c:pt idx="4">
                    <c:v>3.5999999999999997E-2</c:v>
                  </c:pt>
                  <c:pt idx="5">
                    <c:v>3.1E-2</c:v>
                  </c:pt>
                </c:numCache>
              </c:numRef>
            </c:minus>
            <c:spPr>
              <a:noFill/>
              <a:ln w="15875" cap="sq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24-OHase Figure'!$S$6:$S$11</c:f>
              <c:numCache>
                <c:formatCode>General</c:formatCode>
                <c:ptCount val="6"/>
                <c:pt idx="0">
                  <c:v>400</c:v>
                </c:pt>
                <c:pt idx="1">
                  <c:v>800</c:v>
                </c:pt>
                <c:pt idx="2" formatCode="#,##0">
                  <c:v>7400</c:v>
                </c:pt>
                <c:pt idx="3" formatCode="#,##0">
                  <c:v>14000</c:v>
                </c:pt>
                <c:pt idx="4" formatCode="#,##0">
                  <c:v>20000</c:v>
                </c:pt>
                <c:pt idx="5" formatCode="#,##0">
                  <c:v>36000</c:v>
                </c:pt>
              </c:numCache>
            </c:numRef>
          </c:cat>
          <c:val>
            <c:numRef>
              <c:f>'24-OHase Figure'!$T$6:$T$11</c:f>
              <c:numCache>
                <c:formatCode>General</c:formatCode>
                <c:ptCount val="6"/>
                <c:pt idx="0">
                  <c:v>1.3158851895077834</c:v>
                </c:pt>
                <c:pt idx="1">
                  <c:v>1.3174221352581208</c:v>
                </c:pt>
                <c:pt idx="2">
                  <c:v>0.94061140730365067</c:v>
                </c:pt>
                <c:pt idx="3">
                  <c:v>0.93904946398776179</c:v>
                </c:pt>
                <c:pt idx="4">
                  <c:v>1.0016220674265546</c:v>
                </c:pt>
                <c:pt idx="5">
                  <c:v>0.795322246365344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2B3-40EF-9637-97D03ADD48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00870927"/>
        <c:axId val="563385407"/>
      </c:barChart>
      <c:catAx>
        <c:axId val="70087092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Dietary Vitamin D</a:t>
                </a:r>
                <a:r>
                  <a:rPr lang="en-US" baseline="-25000" dirty="0"/>
                  <a:t>3</a:t>
                </a:r>
                <a:r>
                  <a:rPr lang="en-US" dirty="0"/>
                  <a:t> Levels (IU/k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15875" cap="sq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3385407"/>
        <c:crosses val="autoZero"/>
        <c:auto val="1"/>
        <c:lblAlgn val="ctr"/>
        <c:lblOffset val="100"/>
        <c:noMultiLvlLbl val="0"/>
      </c:catAx>
      <c:valAx>
        <c:axId val="563385407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Kidney 24-OHase</a:t>
                </a:r>
              </a:p>
              <a:p>
                <a:pPr>
                  <a:defRPr/>
                </a:pPr>
                <a:r>
                  <a:rPr lang="en-US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15875" cap="sq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0870927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188625096105412"/>
          <c:y val="7.6388888888888895E-2"/>
          <c:w val="0.74181745274264954"/>
          <c:h val="0.672338145231845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α-OHase Figure'!$S$7:$S$8</c:f>
              <c:strCache>
                <c:ptCount val="2"/>
                <c:pt idx="0">
                  <c:v>Relative Expression</c:v>
                </c:pt>
                <c:pt idx="1">
                  <c:v>Mean</c:v>
                </c:pt>
              </c:strCache>
            </c:strRef>
          </c:tx>
          <c:spPr>
            <a:solidFill>
              <a:srgbClr val="FF0000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70C6-4E97-8F06-C583338CFFCE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0C6-4E97-8F06-C583338CFFCE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0C6-4E97-8F06-C583338CFFCE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0C6-4E97-8F06-C583338CFFCE}"/>
              </c:ext>
            </c:extLst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0C6-4E97-8F06-C583338CFFCE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0C6-4E97-8F06-C583338CFFCE}"/>
              </c:ext>
            </c:extLst>
          </c:dPt>
          <c:errBars>
            <c:errBarType val="both"/>
            <c:errValType val="cust"/>
            <c:noEndCap val="0"/>
            <c:plus>
              <c:numRef>
                <c:f>'1α-OHase Figure'!$U$9:$U$14</c:f>
                <c:numCache>
                  <c:formatCode>General</c:formatCode>
                  <c:ptCount val="6"/>
                  <c:pt idx="0">
                    <c:v>7.0999999999999994E-2</c:v>
                  </c:pt>
                  <c:pt idx="1">
                    <c:v>0.11</c:v>
                  </c:pt>
                  <c:pt idx="2">
                    <c:v>0.121</c:v>
                  </c:pt>
                  <c:pt idx="3">
                    <c:v>0.152</c:v>
                  </c:pt>
                  <c:pt idx="4">
                    <c:v>7.5999999999999998E-2</c:v>
                  </c:pt>
                  <c:pt idx="5">
                    <c:v>6.5000000000000002E-2</c:v>
                  </c:pt>
                </c:numCache>
              </c:numRef>
            </c:plus>
            <c:minus>
              <c:numRef>
                <c:f>'1α-OHase Figure'!$U$9:$U$14</c:f>
                <c:numCache>
                  <c:formatCode>General</c:formatCode>
                  <c:ptCount val="6"/>
                  <c:pt idx="0">
                    <c:v>7.0999999999999994E-2</c:v>
                  </c:pt>
                  <c:pt idx="1">
                    <c:v>0.11</c:v>
                  </c:pt>
                  <c:pt idx="2">
                    <c:v>0.121</c:v>
                  </c:pt>
                  <c:pt idx="3">
                    <c:v>0.152</c:v>
                  </c:pt>
                  <c:pt idx="4">
                    <c:v>7.5999999999999998E-2</c:v>
                  </c:pt>
                  <c:pt idx="5">
                    <c:v>6.5000000000000002E-2</c:v>
                  </c:pt>
                </c:numCache>
              </c:numRef>
            </c:minus>
            <c:spPr>
              <a:noFill/>
              <a:ln w="15875" cap="sq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α-OHase Figure'!$R$9:$R$14</c:f>
              <c:numCache>
                <c:formatCode>General</c:formatCode>
                <c:ptCount val="6"/>
                <c:pt idx="0">
                  <c:v>400</c:v>
                </c:pt>
                <c:pt idx="1">
                  <c:v>800</c:v>
                </c:pt>
                <c:pt idx="2" formatCode="#,##0">
                  <c:v>7400</c:v>
                </c:pt>
                <c:pt idx="3" formatCode="#,##0">
                  <c:v>14000</c:v>
                </c:pt>
                <c:pt idx="4" formatCode="#,##0">
                  <c:v>20000</c:v>
                </c:pt>
                <c:pt idx="5" formatCode="#,##0">
                  <c:v>36000</c:v>
                </c:pt>
              </c:numCache>
            </c:numRef>
          </c:cat>
          <c:val>
            <c:numRef>
              <c:f>'1α-OHase Figure'!$S$9:$S$14</c:f>
              <c:numCache>
                <c:formatCode>General</c:formatCode>
                <c:ptCount val="6"/>
                <c:pt idx="0">
                  <c:v>1.032673569547871</c:v>
                </c:pt>
                <c:pt idx="1">
                  <c:v>1.1973377183842255</c:v>
                </c:pt>
                <c:pt idx="2">
                  <c:v>1.1130948724921126</c:v>
                </c:pt>
                <c:pt idx="3">
                  <c:v>0.97862385405582641</c:v>
                </c:pt>
                <c:pt idx="4">
                  <c:v>1.1174372515452651</c:v>
                </c:pt>
                <c:pt idx="5">
                  <c:v>1.1068309758319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0C6-4E97-8F06-C583338CFF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0185055"/>
        <c:axId val="1132149199"/>
      </c:barChart>
      <c:catAx>
        <c:axId val="69018505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Dietary Vitamin D</a:t>
                </a:r>
                <a:r>
                  <a:rPr lang="en-US" baseline="-25000" dirty="0"/>
                  <a:t>3</a:t>
                </a:r>
                <a:r>
                  <a:rPr lang="en-US" dirty="0"/>
                  <a:t> Levels (IU/k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32149199"/>
        <c:crosses val="autoZero"/>
        <c:auto val="1"/>
        <c:lblAlgn val="ctr"/>
        <c:lblOffset val="100"/>
        <c:noMultiLvlLbl val="0"/>
      </c:catAx>
      <c:valAx>
        <c:axId val="1132149199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Kidney 1α-OHase</a:t>
                </a:r>
              </a:p>
              <a:p>
                <a:pPr>
                  <a:defRPr/>
                </a:pPr>
                <a:r>
                  <a:rPr lang="en-US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15875" cap="sq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0185055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sz="9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B9B79-5F9C-4218-B038-9FF5B42378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84E167-79D3-4200-9F3F-7F4312DB14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8AC77A-C734-49CF-9394-AC044DB88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D50143-7FBC-4053-A219-6D2B1C081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CB2AF9-3D4F-4CB9-B8E5-D7104CF02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110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E8642E-2EC2-496F-BD7D-16366703A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B855F6-BC23-430E-9820-6ACBD20EB5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B33ECA-ECB6-4F42-A6F2-907A82C72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9A096-BDD9-4BCF-ADB3-D57972E61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DE4E52-D54B-497B-B5A6-1F2F5ACB8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550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C3F61E7-50C0-4857-994E-9600EAA007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308D32-EE60-4A59-8D3E-905B59EDF8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02F75F-3BEE-48FC-A491-A4D788E88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0E09D-6843-4045-B0E1-148ED67D0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690E91-866B-403F-B5E8-68D73F3D2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614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ECCC3-C377-45CC-9B89-02988C8B25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E1AB0F-4BB8-40C1-A15C-071001AEC7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F3DA34-067F-49D4-AFDC-3B3A4EB06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B7A402-D65E-428F-859A-4787589B8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F6F121-30A7-47FE-B126-787605331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061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4E88DA-6A7F-47AC-B95E-D4BC3D572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46351A-6036-46C8-875F-A51816D871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40670E-DB4C-4018-B874-AF71565CE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83BDCF-4CFA-49E0-9FB1-8F99714CB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CDEE35-FC3C-437A-9473-FE7A81103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875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B2905-E321-43D6-8A99-56CBF5C12A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7F92C0-02E1-445A-8840-559C7C03F0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8BAF10-9E5F-4C33-9E10-95DF148A1D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C3715B-F774-40AD-9D63-5189E9359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698456-D70C-47F0-8410-3FBA66D42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935E70-C18B-4A16-98A0-DC5FABA45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59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56ECF-A4BD-4B0E-99BC-B7DC3C4B2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CFD997-85CD-4869-BD58-06D6463476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C222F5-922D-4FBC-B1C2-B0A9901F79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0D3CCE-8A8E-43B2-9DC4-707139C9A7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6EB6FB5-882E-4FC5-B836-F6E20C97CE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C01E7F1-45E9-4BEB-8116-658601099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D059CD-6BD7-45A4-8BE4-AA778767A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1C3512-D149-4679-B833-E8764AF6F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137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9730D-1A62-466C-A997-7434F12821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46A2F9-8B79-44DE-B101-B444F4BB7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D0372C9-C7D9-4AAA-9CE2-4021C8B47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BB3E94-7591-4D74-B8BC-0F8C308D0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629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D47A00-3AF1-48A9-AEF2-B8A06CAEF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87719D-C2C1-4BD2-BF91-3D0962EAA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A86C62-A20A-411B-8B8B-B7F86A99D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918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19C43C-EDB8-43D7-B2C9-92801AC84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EEE7BE-C437-479D-BFD4-D646EA74BB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B70047-37A6-4616-A0DF-0CC32D34A4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2A6598-F0F0-48AC-8D78-2F2CD25E2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D69D2C-B38D-4D76-9684-EF5091987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E5CEDE-16B2-4D37-957A-EA81A4ED3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785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D1E5F-5946-4D70-A4D5-14B76EB1F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F884CF-0CFB-4115-BA60-F5B4E0CCE5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D7F53A-274D-401F-9D07-9FDCB8AA43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2B5806-3B87-4D11-B508-97E2AA01C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DABD99-52EC-4E8B-AE7E-30E76315C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18DE10-5A35-47D1-B7F7-D384A32DD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933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9FCC055-EE92-49A2-80CF-C0B35D2F0F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E139AF-398E-417B-914E-ECB33A86B9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B86C4D-1AEE-4E0A-94B9-5E39A9BC9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406D9-5C88-4A89-A6F0-D51B9E2FE1D0}" type="datetimeFigureOut">
              <a:rPr lang="en-US" smtClean="0"/>
              <a:t>12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C9FE82-54A0-45C7-A055-60F67A515B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A2461-668D-4166-BC93-274A31C4F0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014C9-AA35-41CE-A7BA-E9D2773B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42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87F81EB-3DF7-4A49-A796-0C67D9E7EF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4224485"/>
              </p:ext>
            </p:extLst>
          </p:nvPr>
        </p:nvGraphicFramePr>
        <p:xfrm>
          <a:off x="4267200" y="492454"/>
          <a:ext cx="36576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66BCE225-93FE-4BEE-8154-6012F3A6B0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4939558"/>
              </p:ext>
            </p:extLst>
          </p:nvPr>
        </p:nvGraphicFramePr>
        <p:xfrm>
          <a:off x="4233545" y="2548431"/>
          <a:ext cx="36576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7C55F9C-2B70-447A-8994-41429A5DB595}"/>
              </a:ext>
            </a:extLst>
          </p:cNvPr>
          <p:cNvSpPr txBox="1"/>
          <p:nvPr/>
        </p:nvSpPr>
        <p:spPr>
          <a:xfrm>
            <a:off x="4371201" y="297839"/>
            <a:ext cx="191312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b="1" dirty="0"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153C03-3C5D-4579-ACEF-FF2098406802}"/>
              </a:ext>
            </a:extLst>
          </p:cNvPr>
          <p:cNvSpPr txBox="1"/>
          <p:nvPr/>
        </p:nvSpPr>
        <p:spPr>
          <a:xfrm>
            <a:off x="4371201" y="2356663"/>
            <a:ext cx="129844" cy="2769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b="1" dirty="0"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" name="Left Brace 1">
            <a:extLst>
              <a:ext uri="{FF2B5EF4-FFF2-40B4-BE49-F238E27FC236}">
                <a16:creationId xmlns:a16="http://schemas.microsoft.com/office/drawing/2014/main" id="{3A438EEE-6869-4D03-B9A0-6EA93C4FB6B7}"/>
              </a:ext>
            </a:extLst>
          </p:cNvPr>
          <p:cNvSpPr/>
          <p:nvPr/>
        </p:nvSpPr>
        <p:spPr>
          <a:xfrm flipH="1">
            <a:off x="7735570" y="667385"/>
            <a:ext cx="165100" cy="275590"/>
          </a:xfrm>
          <a:prstGeom prst="leftBrace">
            <a:avLst>
              <a:gd name="adj1" fmla="val 641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2FD274E-0439-477C-837B-D7FE17FA5E2B}"/>
              </a:ext>
            </a:extLst>
          </p:cNvPr>
          <p:cNvSpPr txBox="1"/>
          <p:nvPr/>
        </p:nvSpPr>
        <p:spPr>
          <a:xfrm>
            <a:off x="7900670" y="695325"/>
            <a:ext cx="111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*</a:t>
            </a:r>
          </a:p>
        </p:txBody>
      </p:sp>
      <p:sp>
        <p:nvSpPr>
          <p:cNvPr id="8" name="Left Brace 7">
            <a:extLst>
              <a:ext uri="{FF2B5EF4-FFF2-40B4-BE49-F238E27FC236}">
                <a16:creationId xmlns:a16="http://schemas.microsoft.com/office/drawing/2014/main" id="{A62E3F7D-EFD2-7E34-0C38-61A5F79A2AF9}"/>
              </a:ext>
            </a:extLst>
          </p:cNvPr>
          <p:cNvSpPr/>
          <p:nvPr/>
        </p:nvSpPr>
        <p:spPr>
          <a:xfrm flipH="1">
            <a:off x="7703820" y="2754891"/>
            <a:ext cx="165100" cy="275590"/>
          </a:xfrm>
          <a:prstGeom prst="leftBrace">
            <a:avLst>
              <a:gd name="adj1" fmla="val 641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FAA2288-1811-DA43-222A-5FEE0429A6C8}"/>
              </a:ext>
            </a:extLst>
          </p:cNvPr>
          <p:cNvSpPr txBox="1"/>
          <p:nvPr/>
        </p:nvSpPr>
        <p:spPr>
          <a:xfrm>
            <a:off x="7868920" y="2782831"/>
            <a:ext cx="111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*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8CCDC9C-6870-22DA-1C19-61AA499212EC}"/>
              </a:ext>
            </a:extLst>
          </p:cNvPr>
          <p:cNvSpPr/>
          <p:nvPr/>
        </p:nvSpPr>
        <p:spPr>
          <a:xfrm>
            <a:off x="7677150" y="2030413"/>
            <a:ext cx="67945" cy="1000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9FB2A42-86BE-F4F5-B1F9-162225053957}"/>
              </a:ext>
            </a:extLst>
          </p:cNvPr>
          <p:cNvSpPr/>
          <p:nvPr/>
        </p:nvSpPr>
        <p:spPr>
          <a:xfrm>
            <a:off x="7697469" y="4219576"/>
            <a:ext cx="67945" cy="1000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BD179A4-5B09-3076-8EAC-0838FB744D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05850" y="5674900"/>
            <a:ext cx="7180299" cy="623248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Percent by weight of bone calcium and phosphorus from 78 </a:t>
            </a:r>
            <a:r>
              <a:rPr lang="en-US" altLang="en-US" sz="9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k</a:t>
            </a:r>
            <a:r>
              <a:rPr lang="en-US" alt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y-Line Brown laying hens fed different levels of dietary D</a:t>
            </a:r>
            <a:r>
              <a:rPr lang="en-US" altLang="en-US" sz="900" b="1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alt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ibia and humerus calcium</a:t>
            </a:r>
            <a:r>
              <a:rPr lang="en-US" alt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)</a:t>
            </a:r>
            <a:r>
              <a:rPr lang="en-US" alt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ibia and humerus phosphorus. Blue squares with lines denote tibia and orange triangles with dashed lines denote humerus (n = 7). Humerus contain more calcium and phosphorus than tibia. Line graphs were expressed as means ± SEM 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ral linear models, p &lt; 0.05). </a:t>
            </a:r>
            <a:endParaRPr lang="en-US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52606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885F4DBC-D189-46E9-A514-731A4CF7995B}"/>
              </a:ext>
            </a:extLst>
          </p:cNvPr>
          <p:cNvGraphicFramePr>
            <a:graphicFrameLocks/>
          </p:cNvGraphicFramePr>
          <p:nvPr/>
        </p:nvGraphicFramePr>
        <p:xfrm>
          <a:off x="2850826" y="2181399"/>
          <a:ext cx="301752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0921D2B1-A31D-4EA9-8345-EA9F46CE3FF7}"/>
              </a:ext>
            </a:extLst>
          </p:cNvPr>
          <p:cNvGraphicFramePr>
            <a:graphicFrameLocks/>
          </p:cNvGraphicFramePr>
          <p:nvPr/>
        </p:nvGraphicFramePr>
        <p:xfrm>
          <a:off x="5778895" y="2181399"/>
          <a:ext cx="301752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Rectangle 20">
            <a:extLst>
              <a:ext uri="{FF2B5EF4-FFF2-40B4-BE49-F238E27FC236}">
                <a16:creationId xmlns:a16="http://schemas.microsoft.com/office/drawing/2014/main" id="{C5261B42-BBF2-42D8-8E03-4BE260F3B2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05850" y="5536402"/>
            <a:ext cx="7180299" cy="900246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. Relative gene expression of kidney vitamin D hydroxylases of 78-wk Hy-Line Brown laying hens fed different levels of dietary vitamin D</a:t>
            </a:r>
            <a:r>
              <a:rPr lang="en-US" altLang="en-US" sz="900" b="1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alt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Kidney 24-hydroxylase (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YP24A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; n = 2-4)</a:t>
            </a:r>
            <a:r>
              <a:rPr lang="en-US" altLang="en-US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 </a:t>
            </a:r>
            <a:r>
              <a:rPr lang="en-US" alt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idney 1α-hydroxylase (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YP27C1</a:t>
            </a:r>
            <a:r>
              <a:rPr lang="en-US" alt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n = 2-5). Relative expression of vitamin D hydroxylase genes were compared to glyceraldehyde phosphate dehydrogenase (GAPDH; housekeeping gene) expression. Blue bars denote standard NRC range vitamin D</a:t>
            </a:r>
            <a:r>
              <a:rPr lang="en-US" altLang="en-US" sz="9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alt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evels in diet and red bars denote super-dose levels of vitamin D</a:t>
            </a:r>
            <a:r>
              <a:rPr lang="en-US" altLang="en-US" sz="900" baseline="-25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altLang="en-US" sz="9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diet. All samples ran in triplicates and reported as means ± SEM. Bars with common letters were not statistically different from each other (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ral linear models, p &lt; 0.05). </a:t>
            </a:r>
            <a:endParaRPr lang="en-US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D90C1C-6FBB-F655-DFC6-D1F4B6E679A7}"/>
              </a:ext>
            </a:extLst>
          </p:cNvPr>
          <p:cNvSpPr txBox="1"/>
          <p:nvPr/>
        </p:nvSpPr>
        <p:spPr>
          <a:xfrm>
            <a:off x="2932315" y="1925616"/>
            <a:ext cx="327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DA3241-B37D-E242-ED62-B491067EC359}"/>
              </a:ext>
            </a:extLst>
          </p:cNvPr>
          <p:cNvSpPr txBox="1"/>
          <p:nvPr/>
        </p:nvSpPr>
        <p:spPr>
          <a:xfrm>
            <a:off x="5841328" y="1925616"/>
            <a:ext cx="327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E844741-54B5-F402-504B-8C5F869D3244}"/>
              </a:ext>
            </a:extLst>
          </p:cNvPr>
          <p:cNvSpPr/>
          <p:nvPr/>
        </p:nvSpPr>
        <p:spPr>
          <a:xfrm>
            <a:off x="5714211" y="3499209"/>
            <a:ext cx="64684" cy="976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3C4D871-6EDA-230C-490E-7A771C91C299}"/>
              </a:ext>
            </a:extLst>
          </p:cNvPr>
          <p:cNvSpPr/>
          <p:nvPr/>
        </p:nvSpPr>
        <p:spPr>
          <a:xfrm>
            <a:off x="8609939" y="3517289"/>
            <a:ext cx="64684" cy="976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0C71579-8EE1-9664-4D65-D261F6E524E6}"/>
              </a:ext>
            </a:extLst>
          </p:cNvPr>
          <p:cNvSpPr/>
          <p:nvPr/>
        </p:nvSpPr>
        <p:spPr>
          <a:xfrm>
            <a:off x="8609938" y="3499208"/>
            <a:ext cx="64684" cy="976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818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269</Words>
  <Application>Microsoft Office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F. Warren</dc:creator>
  <cp:lastModifiedBy>Matthew F. Warren</cp:lastModifiedBy>
  <cp:revision>14</cp:revision>
  <dcterms:created xsi:type="dcterms:W3CDTF">2020-03-05T15:21:34Z</dcterms:created>
  <dcterms:modified xsi:type="dcterms:W3CDTF">2023-12-29T03:35:30Z</dcterms:modified>
</cp:coreProperties>
</file>